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media/image2.svg" ContentType="image/svg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7" r:id="rId3"/>
  </p:sldIdLst>
  <p:sldSz cx="9144000" cy="6858000" type="screen4x3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284" y="-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sv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形 6"/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1365999" y="1208103"/>
            <a:ext cx="6412002" cy="3062778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320974" y="4401279"/>
            <a:ext cx="6502052" cy="829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 Overall survival stratified by postoperative ctDNA status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A and B) Kaplan-Meier estimates of overall survival in patients stratified by ctDNA status at landmark (A) and during longitudinal surveillance (B).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value was calculated by the log-rank test and hazard ratio by the Cox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ex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bet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method.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adc0015f-a85e-4dcb-974d-f2a826d0cd7e"/>
  <p:tag name="COMMONDATA" val="eyJoZGlkIjoiZjJkNmJiODU1NzA1YWVjNGUwNTk3ZDA3NTIxZGRlMDUifQ=="/>
</p:tagLst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7</Words>
  <Application>WPS 演示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微软雅黑</vt:lpstr>
      <vt:lpstr>Arial Unicode MS</vt:lpstr>
      <vt:lpstr>等线 Light</vt:lpstr>
      <vt:lpstr>Calibri Light</vt:lpstr>
      <vt:lpstr>等线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eneplus</dc:creator>
  <cp:lastModifiedBy>熊歪歪</cp:lastModifiedBy>
  <cp:revision>30</cp:revision>
  <dcterms:created xsi:type="dcterms:W3CDTF">2022-12-19T12:12:00Z</dcterms:created>
  <dcterms:modified xsi:type="dcterms:W3CDTF">2023-01-29T13:43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D74A3FC939243238FFA33F338A39700</vt:lpwstr>
  </property>
  <property fmtid="{D5CDD505-2E9C-101B-9397-08002B2CF9AE}" pid="3" name="KSOProductBuildVer">
    <vt:lpwstr>2052-11.1.0.13703</vt:lpwstr>
  </property>
</Properties>
</file>